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69" r:id="rId2"/>
  </p:sldIdLst>
  <p:sldSz cx="7559675" cy="10691813"/>
  <p:notesSz cx="6858000" cy="9144000"/>
  <p:defaultTextStyle>
    <a:defPPr>
      <a:defRPr lang="fr-FR"/>
    </a:defPPr>
    <a:lvl1pPr marL="0" algn="l" defTabSz="785744" rtl="0" eaLnBrk="1" latinLnBrk="0" hangingPunct="1">
      <a:defRPr sz="1547" kern="1200">
        <a:solidFill>
          <a:schemeClr val="tx1"/>
        </a:solidFill>
        <a:latin typeface="+mn-lt"/>
        <a:ea typeface="+mn-ea"/>
        <a:cs typeface="+mn-cs"/>
      </a:defRPr>
    </a:lvl1pPr>
    <a:lvl2pPr marL="392872" algn="l" defTabSz="785744" rtl="0" eaLnBrk="1" latinLnBrk="0" hangingPunct="1">
      <a:defRPr sz="1547" kern="1200">
        <a:solidFill>
          <a:schemeClr val="tx1"/>
        </a:solidFill>
        <a:latin typeface="+mn-lt"/>
        <a:ea typeface="+mn-ea"/>
        <a:cs typeface="+mn-cs"/>
      </a:defRPr>
    </a:lvl2pPr>
    <a:lvl3pPr marL="785744" algn="l" defTabSz="785744" rtl="0" eaLnBrk="1" latinLnBrk="0" hangingPunct="1">
      <a:defRPr sz="1547" kern="1200">
        <a:solidFill>
          <a:schemeClr val="tx1"/>
        </a:solidFill>
        <a:latin typeface="+mn-lt"/>
        <a:ea typeface="+mn-ea"/>
        <a:cs typeface="+mn-cs"/>
      </a:defRPr>
    </a:lvl3pPr>
    <a:lvl4pPr marL="1178616" algn="l" defTabSz="785744" rtl="0" eaLnBrk="1" latinLnBrk="0" hangingPunct="1">
      <a:defRPr sz="1547" kern="1200">
        <a:solidFill>
          <a:schemeClr val="tx1"/>
        </a:solidFill>
        <a:latin typeface="+mn-lt"/>
        <a:ea typeface="+mn-ea"/>
        <a:cs typeface="+mn-cs"/>
      </a:defRPr>
    </a:lvl4pPr>
    <a:lvl5pPr marL="1571488" algn="l" defTabSz="785744" rtl="0" eaLnBrk="1" latinLnBrk="0" hangingPunct="1">
      <a:defRPr sz="1547" kern="1200">
        <a:solidFill>
          <a:schemeClr val="tx1"/>
        </a:solidFill>
        <a:latin typeface="+mn-lt"/>
        <a:ea typeface="+mn-ea"/>
        <a:cs typeface="+mn-cs"/>
      </a:defRPr>
    </a:lvl5pPr>
    <a:lvl6pPr marL="1964360" algn="l" defTabSz="785744" rtl="0" eaLnBrk="1" latinLnBrk="0" hangingPunct="1">
      <a:defRPr sz="1547" kern="1200">
        <a:solidFill>
          <a:schemeClr val="tx1"/>
        </a:solidFill>
        <a:latin typeface="+mn-lt"/>
        <a:ea typeface="+mn-ea"/>
        <a:cs typeface="+mn-cs"/>
      </a:defRPr>
    </a:lvl6pPr>
    <a:lvl7pPr marL="2357232" algn="l" defTabSz="785744" rtl="0" eaLnBrk="1" latinLnBrk="0" hangingPunct="1">
      <a:defRPr sz="1547" kern="1200">
        <a:solidFill>
          <a:schemeClr val="tx1"/>
        </a:solidFill>
        <a:latin typeface="+mn-lt"/>
        <a:ea typeface="+mn-ea"/>
        <a:cs typeface="+mn-cs"/>
      </a:defRPr>
    </a:lvl7pPr>
    <a:lvl8pPr marL="2750104" algn="l" defTabSz="785744" rtl="0" eaLnBrk="1" latinLnBrk="0" hangingPunct="1">
      <a:defRPr sz="1547" kern="1200">
        <a:solidFill>
          <a:schemeClr val="tx1"/>
        </a:solidFill>
        <a:latin typeface="+mn-lt"/>
        <a:ea typeface="+mn-ea"/>
        <a:cs typeface="+mn-cs"/>
      </a:defRPr>
    </a:lvl8pPr>
    <a:lvl9pPr marL="3142976" algn="l" defTabSz="785744" rtl="0" eaLnBrk="1" latinLnBrk="0" hangingPunct="1">
      <a:defRPr sz="1547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367">
          <p15:clr>
            <a:srgbClr val="A4A3A4"/>
          </p15:clr>
        </p15:guide>
        <p15:guide id="2" pos="238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0" d="100"/>
          <a:sy n="80" d="100"/>
        </p:scale>
        <p:origin x="3182" y="48"/>
      </p:cViewPr>
      <p:guideLst>
        <p:guide orient="horz" pos="3367"/>
        <p:guide pos="2381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0EDC75A-50A8-45CB-8BEE-D6D8FC1E3C65}" type="datetimeFigureOut">
              <a:rPr lang="fr-FR" smtClean="0"/>
              <a:pPr/>
              <a:t>30/04/2025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338388" y="1143000"/>
            <a:ext cx="21812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A8F8E05-B511-48FD-9701-AB61F8719141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337333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785744" rtl="0" eaLnBrk="1" latinLnBrk="0" hangingPunct="1">
      <a:defRPr sz="1031" kern="1200">
        <a:solidFill>
          <a:schemeClr val="tx1"/>
        </a:solidFill>
        <a:latin typeface="+mn-lt"/>
        <a:ea typeface="+mn-ea"/>
        <a:cs typeface="+mn-cs"/>
      </a:defRPr>
    </a:lvl1pPr>
    <a:lvl2pPr marL="392872" algn="l" defTabSz="785744" rtl="0" eaLnBrk="1" latinLnBrk="0" hangingPunct="1">
      <a:defRPr sz="1031" kern="1200">
        <a:solidFill>
          <a:schemeClr val="tx1"/>
        </a:solidFill>
        <a:latin typeface="+mn-lt"/>
        <a:ea typeface="+mn-ea"/>
        <a:cs typeface="+mn-cs"/>
      </a:defRPr>
    </a:lvl2pPr>
    <a:lvl3pPr marL="785744" algn="l" defTabSz="785744" rtl="0" eaLnBrk="1" latinLnBrk="0" hangingPunct="1">
      <a:defRPr sz="1031" kern="1200">
        <a:solidFill>
          <a:schemeClr val="tx1"/>
        </a:solidFill>
        <a:latin typeface="+mn-lt"/>
        <a:ea typeface="+mn-ea"/>
        <a:cs typeface="+mn-cs"/>
      </a:defRPr>
    </a:lvl3pPr>
    <a:lvl4pPr marL="1178616" algn="l" defTabSz="785744" rtl="0" eaLnBrk="1" latinLnBrk="0" hangingPunct="1">
      <a:defRPr sz="1031" kern="1200">
        <a:solidFill>
          <a:schemeClr val="tx1"/>
        </a:solidFill>
        <a:latin typeface="+mn-lt"/>
        <a:ea typeface="+mn-ea"/>
        <a:cs typeface="+mn-cs"/>
      </a:defRPr>
    </a:lvl4pPr>
    <a:lvl5pPr marL="1571488" algn="l" defTabSz="785744" rtl="0" eaLnBrk="1" latinLnBrk="0" hangingPunct="1">
      <a:defRPr sz="1031" kern="1200">
        <a:solidFill>
          <a:schemeClr val="tx1"/>
        </a:solidFill>
        <a:latin typeface="+mn-lt"/>
        <a:ea typeface="+mn-ea"/>
        <a:cs typeface="+mn-cs"/>
      </a:defRPr>
    </a:lvl5pPr>
    <a:lvl6pPr marL="1964360" algn="l" defTabSz="785744" rtl="0" eaLnBrk="1" latinLnBrk="0" hangingPunct="1">
      <a:defRPr sz="1031" kern="1200">
        <a:solidFill>
          <a:schemeClr val="tx1"/>
        </a:solidFill>
        <a:latin typeface="+mn-lt"/>
        <a:ea typeface="+mn-ea"/>
        <a:cs typeface="+mn-cs"/>
      </a:defRPr>
    </a:lvl6pPr>
    <a:lvl7pPr marL="2357232" algn="l" defTabSz="785744" rtl="0" eaLnBrk="1" latinLnBrk="0" hangingPunct="1">
      <a:defRPr sz="1031" kern="1200">
        <a:solidFill>
          <a:schemeClr val="tx1"/>
        </a:solidFill>
        <a:latin typeface="+mn-lt"/>
        <a:ea typeface="+mn-ea"/>
        <a:cs typeface="+mn-cs"/>
      </a:defRPr>
    </a:lvl7pPr>
    <a:lvl8pPr marL="2750104" algn="l" defTabSz="785744" rtl="0" eaLnBrk="1" latinLnBrk="0" hangingPunct="1">
      <a:defRPr sz="1031" kern="1200">
        <a:solidFill>
          <a:schemeClr val="tx1"/>
        </a:solidFill>
        <a:latin typeface="+mn-lt"/>
        <a:ea typeface="+mn-ea"/>
        <a:cs typeface="+mn-cs"/>
      </a:defRPr>
    </a:lvl8pPr>
    <a:lvl9pPr marL="3142976" algn="l" defTabSz="785744" rtl="0" eaLnBrk="1" latinLnBrk="0" hangingPunct="1">
      <a:defRPr sz="1031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49795"/>
            <a:ext cx="6425724" cy="3722335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615678"/>
            <a:ext cx="5669756" cy="2581379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fr-FR" smtClean="0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1B7FAA-9DAF-4D36-B2ED-D8C5EB0CC574}" type="datetimeFigureOut">
              <a:rPr lang="fr-FR" smtClean="0"/>
              <a:pPr/>
              <a:t>30/04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9CFF56-F15A-4D8E-B31F-53AD2BA3B870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150162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1B7FAA-9DAF-4D36-B2ED-D8C5EB0CC574}" type="datetimeFigureOut">
              <a:rPr lang="fr-FR" smtClean="0"/>
              <a:pPr/>
              <a:t>30/04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9CFF56-F15A-4D8E-B31F-53AD2BA3B870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862137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69240"/>
            <a:ext cx="1630055" cy="9060817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69240"/>
            <a:ext cx="4795669" cy="9060817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1B7FAA-9DAF-4D36-B2ED-D8C5EB0CC574}" type="datetimeFigureOut">
              <a:rPr lang="fr-FR" smtClean="0"/>
              <a:pPr/>
              <a:t>30/04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9CFF56-F15A-4D8E-B31F-53AD2BA3B870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490058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1B7FAA-9DAF-4D36-B2ED-D8C5EB0CC574}" type="datetimeFigureOut">
              <a:rPr lang="fr-FR" smtClean="0"/>
              <a:pPr/>
              <a:t>30/04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9CFF56-F15A-4D8E-B31F-53AD2BA3B870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461559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65532"/>
            <a:ext cx="6520220" cy="4447496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7155103"/>
            <a:ext cx="6520220" cy="2338833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1B7FAA-9DAF-4D36-B2ED-D8C5EB0CC574}" type="datetimeFigureOut">
              <a:rPr lang="fr-FR" smtClean="0"/>
              <a:pPr/>
              <a:t>30/04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9CFF56-F15A-4D8E-B31F-53AD2BA3B870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696311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846200"/>
            <a:ext cx="3212862" cy="6783857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846200"/>
            <a:ext cx="3212862" cy="6783857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1B7FAA-9DAF-4D36-B2ED-D8C5EB0CC574}" type="datetimeFigureOut">
              <a:rPr lang="fr-FR" smtClean="0"/>
              <a:pPr/>
              <a:t>30/04/2025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9CFF56-F15A-4D8E-B31F-53AD2BA3B870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917260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69242"/>
            <a:ext cx="6520220" cy="2066590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620980"/>
            <a:ext cx="3198096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905482"/>
            <a:ext cx="3198096" cy="5744375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620980"/>
            <a:ext cx="3213847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905482"/>
            <a:ext cx="3213847" cy="5744375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1B7FAA-9DAF-4D36-B2ED-D8C5EB0CC574}" type="datetimeFigureOut">
              <a:rPr lang="fr-FR" smtClean="0"/>
              <a:pPr/>
              <a:t>30/04/2025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9CFF56-F15A-4D8E-B31F-53AD2BA3B870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470898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1B7FAA-9DAF-4D36-B2ED-D8C5EB0CC574}" type="datetimeFigureOut">
              <a:rPr lang="fr-FR" smtClean="0"/>
              <a:pPr/>
              <a:t>30/04/2025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9CFF56-F15A-4D8E-B31F-53AD2BA3B870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042508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1B7FAA-9DAF-4D36-B2ED-D8C5EB0CC574}" type="datetimeFigureOut">
              <a:rPr lang="fr-FR" smtClean="0"/>
              <a:pPr/>
              <a:t>30/04/2025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9CFF56-F15A-4D8E-B31F-53AD2BA3B870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727231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39425"/>
            <a:ext cx="3827085" cy="7598117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1B7FAA-9DAF-4D36-B2ED-D8C5EB0CC574}" type="datetimeFigureOut">
              <a:rPr lang="fr-FR" smtClean="0"/>
              <a:pPr/>
              <a:t>30/04/2025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9CFF56-F15A-4D8E-B31F-53AD2BA3B870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636746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39425"/>
            <a:ext cx="3827085" cy="7598117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1B7FAA-9DAF-4D36-B2ED-D8C5EB0CC574}" type="datetimeFigureOut">
              <a:rPr lang="fr-FR" smtClean="0"/>
              <a:pPr/>
              <a:t>30/04/2025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9CFF56-F15A-4D8E-B31F-53AD2BA3B870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089795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69242"/>
            <a:ext cx="6520220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846200"/>
            <a:ext cx="6520220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1B7FAA-9DAF-4D36-B2ED-D8C5EB0CC574}" type="datetimeFigureOut">
              <a:rPr lang="fr-FR" smtClean="0"/>
              <a:pPr/>
              <a:t>30/04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9CFF56-F15A-4D8E-B31F-53AD2BA3B870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2560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ZoneTexte 5"/>
          <p:cNvSpPr txBox="1"/>
          <p:nvPr/>
        </p:nvSpPr>
        <p:spPr>
          <a:xfrm>
            <a:off x="766483" y="363071"/>
            <a:ext cx="6016934" cy="56848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Additional File 1: Statistical results of the </a:t>
            </a:r>
            <a:r>
              <a:rPr lang="en-US" dirty="0" err="1" smtClean="0"/>
              <a:t>Kruskal</a:t>
            </a:r>
            <a:r>
              <a:rPr lang="en-US" dirty="0" smtClean="0"/>
              <a:t>-Wallis test significant for the different figures.</a:t>
            </a:r>
            <a:endParaRPr lang="en-US" dirty="0"/>
          </a:p>
        </p:txBody>
      </p:sp>
      <p:graphicFrame>
        <p:nvGraphicFramePr>
          <p:cNvPr id="7" name="Tableau 6"/>
          <p:cNvGraphicFramePr>
            <a:graphicFrameLocks noGrp="1"/>
          </p:cNvGraphicFramePr>
          <p:nvPr/>
        </p:nvGraphicFramePr>
        <p:xfrm>
          <a:off x="634999" y="1074736"/>
          <a:ext cx="6242050" cy="4408971"/>
        </p:xfrm>
        <a:graphic>
          <a:graphicData uri="http://schemas.openxmlformats.org/drawingml/2006/table">
            <a:tbl>
              <a:tblPr/>
              <a:tblGrid>
                <a:gridCol w="309880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8669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581561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694788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147609">
                <a:tc>
                  <a:txBody>
                    <a:bodyPr/>
                    <a:lstStyle/>
                    <a:p>
                      <a:pPr algn="ctr" fontAlgn="b"/>
                      <a:r>
                        <a:rPr lang="fr-FR" sz="105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Figures</a:t>
                      </a:r>
                    </a:p>
                  </a:txBody>
                  <a:tcPr marL="4211" marR="4211" marT="4211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5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Kruskal-Wallis</a:t>
                      </a:r>
                    </a:p>
                  </a:txBody>
                  <a:tcPr marL="4211" marR="4211" marT="421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50" b="1" i="1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P</a:t>
                      </a:r>
                      <a:r>
                        <a:rPr lang="fr-FR" sz="105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-value</a:t>
                      </a:r>
                    </a:p>
                  </a:txBody>
                  <a:tcPr marL="4211" marR="4211" marT="421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5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Significance</a:t>
                      </a:r>
                    </a:p>
                  </a:txBody>
                  <a:tcPr marL="4211" marR="4211" marT="4211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47609">
                <a:tc>
                  <a:txBody>
                    <a:bodyPr/>
                    <a:lstStyle/>
                    <a:p>
                      <a:pPr algn="l" fontAlgn="b"/>
                      <a:r>
                        <a:rPr lang="fr-FR" sz="105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Figure 2C:</a:t>
                      </a:r>
                      <a:r>
                        <a:rPr lang="fr-FR" sz="105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Lung </a:t>
                      </a:r>
                      <a:r>
                        <a:rPr lang="fr-FR" sz="105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lesions</a:t>
                      </a:r>
                      <a:r>
                        <a:rPr lang="fr-FR" sz="105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(</a:t>
                      </a:r>
                      <a:r>
                        <a:rPr lang="fr-FR" sz="105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jung</a:t>
                      </a:r>
                      <a:r>
                        <a:rPr lang="fr-FR" sz="105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score)</a:t>
                      </a:r>
                    </a:p>
                  </a:txBody>
                  <a:tcPr marL="4211" marR="4211" marT="4211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05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Mock-D7 </a:t>
                      </a:r>
                      <a:r>
                        <a:rPr lang="fr-FR" sz="105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vs</a:t>
                      </a:r>
                      <a:r>
                        <a:rPr lang="fr-FR" sz="105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 swIAV/PRRSV-D14</a:t>
                      </a:r>
                    </a:p>
                  </a:txBody>
                  <a:tcPr marL="4211" marR="4211" marT="421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5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0.0228</a:t>
                      </a:r>
                    </a:p>
                  </a:txBody>
                  <a:tcPr marL="4211" marR="4211" marT="421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5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*</a:t>
                      </a:r>
                    </a:p>
                  </a:txBody>
                  <a:tcPr marL="4211" marR="4211" marT="4211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47363">
                <a:tc rowSpan="2">
                  <a:txBody>
                    <a:bodyPr/>
                    <a:lstStyle/>
                    <a:p>
                      <a:pPr algn="l" fontAlgn="ctr"/>
                      <a:r>
                        <a:rPr lang="fr-FR" sz="105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Figure 2D:</a:t>
                      </a:r>
                      <a:r>
                        <a:rPr lang="fr-FR" sz="105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Lung </a:t>
                      </a:r>
                      <a:r>
                        <a:rPr lang="fr-FR" sz="105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lesions</a:t>
                      </a:r>
                      <a:r>
                        <a:rPr lang="fr-FR" sz="105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(composite score)</a:t>
                      </a:r>
                    </a:p>
                  </a:txBody>
                  <a:tcPr marL="4211" marR="4211" marT="421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05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Mock-D7 </a:t>
                      </a:r>
                      <a:r>
                        <a:rPr lang="fr-FR" sz="105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vs </a:t>
                      </a:r>
                      <a:r>
                        <a:rPr lang="fr-FR" sz="105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PRRSV-D14</a:t>
                      </a:r>
                    </a:p>
                  </a:txBody>
                  <a:tcPr marL="4211" marR="4211" marT="421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5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0.0082</a:t>
                      </a:r>
                    </a:p>
                  </a:txBody>
                  <a:tcPr marL="4211" marR="4211" marT="421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5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**</a:t>
                      </a:r>
                    </a:p>
                  </a:txBody>
                  <a:tcPr marL="4211" marR="4211" marT="4211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47609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05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Mock-D7 </a:t>
                      </a:r>
                      <a:r>
                        <a:rPr lang="fr-FR" sz="105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vs</a:t>
                      </a:r>
                      <a:r>
                        <a:rPr lang="fr-FR" sz="105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 swIAV/PRRSV-D14</a:t>
                      </a:r>
                    </a:p>
                  </a:txBody>
                  <a:tcPr marL="4211" marR="4211" marT="421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5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0.0399</a:t>
                      </a:r>
                    </a:p>
                  </a:txBody>
                  <a:tcPr marL="4211" marR="4211" marT="421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5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*</a:t>
                      </a:r>
                    </a:p>
                  </a:txBody>
                  <a:tcPr marL="4211" marR="4211" marT="4211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47609">
                <a:tc>
                  <a:txBody>
                    <a:bodyPr/>
                    <a:lstStyle/>
                    <a:p>
                      <a:pPr algn="just" fontAlgn="ctr"/>
                      <a:r>
                        <a:rPr lang="it-IT" sz="105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Figure 4C:</a:t>
                      </a:r>
                      <a:r>
                        <a:rPr lang="it-IT" sz="105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 Cytokine profile in BALF (IL-6)</a:t>
                      </a:r>
                      <a:endParaRPr lang="it-IT" sz="1050" b="1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211" marR="4211" marT="421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05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Mock-D7 </a:t>
                      </a:r>
                      <a:r>
                        <a:rPr lang="fr-FR" sz="105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vs</a:t>
                      </a:r>
                      <a:r>
                        <a:rPr lang="fr-FR" sz="105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 swIAV-D7</a:t>
                      </a:r>
                    </a:p>
                  </a:txBody>
                  <a:tcPr marL="4211" marR="4211" marT="421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5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0.0382</a:t>
                      </a:r>
                    </a:p>
                  </a:txBody>
                  <a:tcPr marL="4211" marR="4211" marT="421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5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*</a:t>
                      </a:r>
                    </a:p>
                  </a:txBody>
                  <a:tcPr marL="4211" marR="4211" marT="4211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47609">
                <a:tc>
                  <a:txBody>
                    <a:bodyPr/>
                    <a:lstStyle/>
                    <a:p>
                      <a:pPr algn="just" fontAlgn="ctr"/>
                      <a:r>
                        <a:rPr lang="it-IT" sz="105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Figure 4F:</a:t>
                      </a:r>
                      <a:r>
                        <a:rPr lang="it-IT" sz="105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 Cytokine profile in BALF (IL-12)</a:t>
                      </a:r>
                      <a:endParaRPr lang="it-IT" sz="1050" b="1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211" marR="4211" marT="421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05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Mock-D7 </a:t>
                      </a:r>
                      <a:r>
                        <a:rPr lang="fr-FR" sz="105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vs</a:t>
                      </a:r>
                      <a:r>
                        <a:rPr lang="fr-FR" sz="105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 swIAV/PRRSV-D14</a:t>
                      </a:r>
                    </a:p>
                  </a:txBody>
                  <a:tcPr marL="4211" marR="4211" marT="421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5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0.0032</a:t>
                      </a:r>
                    </a:p>
                  </a:txBody>
                  <a:tcPr marL="4211" marR="4211" marT="421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5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**</a:t>
                      </a:r>
                    </a:p>
                  </a:txBody>
                  <a:tcPr marL="4211" marR="4211" marT="4211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90300"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5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Figure 5C:</a:t>
                      </a:r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 Absolute numbers of myeloid cell populations in the BAL (cDC1)</a:t>
                      </a:r>
                      <a:endParaRPr lang="en-US" sz="1050" b="1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211" marR="4211" marT="421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105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Mock-D7 </a:t>
                      </a:r>
                      <a:r>
                        <a:rPr lang="fr-FR" sz="105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vs</a:t>
                      </a:r>
                      <a:r>
                        <a:rPr lang="fr-FR" sz="105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 swIAV/PRRSV-D14</a:t>
                      </a:r>
                    </a:p>
                  </a:txBody>
                  <a:tcPr marL="4211" marR="4211" marT="42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5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0.0430</a:t>
                      </a:r>
                    </a:p>
                  </a:txBody>
                  <a:tcPr marL="4211" marR="4211" marT="42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5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*</a:t>
                      </a:r>
                    </a:p>
                  </a:txBody>
                  <a:tcPr marL="4211" marR="4211" marT="4211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47363"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105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Figure 6C:</a:t>
                      </a:r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 Proportions of regulatory and conventional CD4 T cells in BAL (Tconv)</a:t>
                      </a:r>
                      <a:endParaRPr lang="en-US" sz="1050" b="1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211" marR="4211" marT="421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105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Mock</a:t>
                      </a:r>
                      <a:r>
                        <a:rPr lang="fr-FR" sz="105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-D7 </a:t>
                      </a:r>
                      <a:r>
                        <a:rPr lang="fr-FR" sz="1050" b="0" i="1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vs</a:t>
                      </a:r>
                      <a:r>
                        <a:rPr lang="fr-FR" sz="105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lang="fr-FR" sz="105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swIAV</a:t>
                      </a:r>
                      <a:r>
                        <a:rPr lang="fr-FR" sz="105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/PRRSV-D14</a:t>
                      </a:r>
                    </a:p>
                  </a:txBody>
                  <a:tcPr marL="4211" marR="4211" marT="42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5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0.0319</a:t>
                      </a:r>
                    </a:p>
                  </a:txBody>
                  <a:tcPr marL="4211" marR="4211" marT="42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5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*</a:t>
                      </a:r>
                    </a:p>
                  </a:txBody>
                  <a:tcPr marL="4211" marR="4211" marT="4211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47609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105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PRRSV-D10 </a:t>
                      </a:r>
                      <a:r>
                        <a:rPr lang="fr-FR" sz="105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vs</a:t>
                      </a:r>
                      <a:r>
                        <a:rPr lang="fr-FR" sz="105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 swIAV/PRRSV-D14</a:t>
                      </a:r>
                    </a:p>
                  </a:txBody>
                  <a:tcPr marL="4211" marR="4211" marT="42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5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0.0110</a:t>
                      </a:r>
                    </a:p>
                  </a:txBody>
                  <a:tcPr marL="4211" marR="4211" marT="42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5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*</a:t>
                      </a:r>
                    </a:p>
                  </a:txBody>
                  <a:tcPr marL="4211" marR="4211" marT="4211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90300"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5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Figure 6D:</a:t>
                      </a:r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 Proportions of regulatory and conventional CD4 T cells in BAL (Treg)</a:t>
                      </a:r>
                      <a:endParaRPr lang="en-US" sz="1050" b="1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211" marR="4211" marT="421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105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PRRSV-D10 </a:t>
                      </a:r>
                      <a:r>
                        <a:rPr lang="fr-FR" sz="1050" b="0" i="1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vs</a:t>
                      </a:r>
                      <a:r>
                        <a:rPr lang="fr-FR" sz="105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lang="fr-FR" sz="105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swIAV</a:t>
                      </a:r>
                      <a:r>
                        <a:rPr lang="fr-FR" sz="105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/PRRSV-D14</a:t>
                      </a:r>
                    </a:p>
                  </a:txBody>
                  <a:tcPr marL="4211" marR="4211" marT="42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5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0.0455</a:t>
                      </a:r>
                    </a:p>
                  </a:txBody>
                  <a:tcPr marL="4211" marR="4211" marT="42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5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*</a:t>
                      </a:r>
                    </a:p>
                  </a:txBody>
                  <a:tcPr marL="4211" marR="4211" marT="4211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903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5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Figure 7A:</a:t>
                      </a:r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 Proportions of lymphoid cell populations in the BAL (cluster 6)</a:t>
                      </a:r>
                      <a:endParaRPr lang="en-US" sz="1050" b="1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211" marR="4211" marT="421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105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Mock-D7 </a:t>
                      </a:r>
                      <a:r>
                        <a:rPr lang="fr-FR" sz="105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vs</a:t>
                      </a:r>
                      <a:r>
                        <a:rPr lang="fr-FR" sz="105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 swIAV/PRRSV-D10</a:t>
                      </a:r>
                    </a:p>
                  </a:txBody>
                  <a:tcPr marL="4211" marR="4211" marT="42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5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0.0003</a:t>
                      </a:r>
                    </a:p>
                  </a:txBody>
                  <a:tcPr marL="4211" marR="4211" marT="42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5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***</a:t>
                      </a:r>
                    </a:p>
                  </a:txBody>
                  <a:tcPr marL="4211" marR="4211" marT="4211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903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5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Figure 7B:</a:t>
                      </a:r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 Proportions of lymphoid cell populations in the BAL (cluster 7)</a:t>
                      </a:r>
                      <a:endParaRPr lang="en-US" sz="1050" b="1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211" marR="4211" marT="421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105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swIAV/PRRSV-D10 </a:t>
                      </a:r>
                      <a:r>
                        <a:rPr lang="fr-FR" sz="105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vs</a:t>
                      </a:r>
                      <a:r>
                        <a:rPr lang="fr-FR" sz="105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 PRRSV-D14</a:t>
                      </a:r>
                    </a:p>
                  </a:txBody>
                  <a:tcPr marL="4211" marR="4211" marT="42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5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0.0452</a:t>
                      </a:r>
                    </a:p>
                  </a:txBody>
                  <a:tcPr marL="4211" marR="4211" marT="42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5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*</a:t>
                      </a:r>
                    </a:p>
                  </a:txBody>
                  <a:tcPr marL="4211" marR="4211" marT="4211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47363"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105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Figure 7C:</a:t>
                      </a:r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 Proportions of lymphoid cell populations in the BAL (cluster 8)</a:t>
                      </a:r>
                      <a:endParaRPr lang="en-US" sz="1050" b="1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211" marR="4211" marT="421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105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Mock-D7 </a:t>
                      </a:r>
                      <a:r>
                        <a:rPr lang="fr-FR" sz="105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vs</a:t>
                      </a:r>
                      <a:r>
                        <a:rPr lang="fr-FR" sz="105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 swIAV/PRRSV-D10</a:t>
                      </a:r>
                    </a:p>
                  </a:txBody>
                  <a:tcPr marL="4211" marR="4211" marT="42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5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0.0161</a:t>
                      </a:r>
                    </a:p>
                  </a:txBody>
                  <a:tcPr marL="4211" marR="4211" marT="421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5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*</a:t>
                      </a:r>
                    </a:p>
                  </a:txBody>
                  <a:tcPr marL="4211" marR="4211" marT="4211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47609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105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swIAV/PRRSV-D10 </a:t>
                      </a:r>
                      <a:r>
                        <a:rPr lang="fr-FR" sz="105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vs</a:t>
                      </a:r>
                      <a:r>
                        <a:rPr lang="fr-FR" sz="105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 PRRSV-D14</a:t>
                      </a:r>
                    </a:p>
                  </a:txBody>
                  <a:tcPr marL="4211" marR="4211" marT="42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5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0.0428</a:t>
                      </a:r>
                    </a:p>
                  </a:txBody>
                  <a:tcPr marL="4211" marR="4211" marT="421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5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*</a:t>
                      </a:r>
                    </a:p>
                  </a:txBody>
                  <a:tcPr marL="4211" marR="4211" marT="4211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147363">
                <a:tc rowSpan="3">
                  <a:txBody>
                    <a:bodyPr/>
                    <a:lstStyle/>
                    <a:p>
                      <a:pPr algn="l" fontAlgn="ctr"/>
                      <a:r>
                        <a:rPr lang="en-US" sz="105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Figure 7D:</a:t>
                      </a:r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 Proportions of lymphoid cell populations in the BAL (cluster 9)</a:t>
                      </a:r>
                      <a:endParaRPr lang="en-US" sz="1050" b="1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211" marR="4211" marT="421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105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Mock-D7 </a:t>
                      </a:r>
                      <a:r>
                        <a:rPr lang="fr-FR" sz="105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vs</a:t>
                      </a:r>
                      <a:r>
                        <a:rPr lang="fr-FR" sz="105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 swIAV/PRRSV-D10</a:t>
                      </a:r>
                    </a:p>
                  </a:txBody>
                  <a:tcPr marL="4211" marR="4211" marT="42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5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0.0140</a:t>
                      </a:r>
                    </a:p>
                  </a:txBody>
                  <a:tcPr marL="4211" marR="4211" marT="421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5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*</a:t>
                      </a:r>
                    </a:p>
                  </a:txBody>
                  <a:tcPr marL="4211" marR="4211" marT="4211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147363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105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Mock-D7 </a:t>
                      </a:r>
                      <a:r>
                        <a:rPr lang="fr-FR" sz="105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vs</a:t>
                      </a:r>
                      <a:r>
                        <a:rPr lang="fr-FR" sz="105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 swIAV/PRRSV-D14</a:t>
                      </a:r>
                    </a:p>
                  </a:txBody>
                  <a:tcPr marL="4211" marR="4211" marT="42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5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0.0011</a:t>
                      </a:r>
                    </a:p>
                  </a:txBody>
                  <a:tcPr marL="4211" marR="4211" marT="421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5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**</a:t>
                      </a:r>
                    </a:p>
                  </a:txBody>
                  <a:tcPr marL="4211" marR="4211" marT="4211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147609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105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swIAV/PRRSV-D14 </a:t>
                      </a:r>
                      <a:r>
                        <a:rPr lang="fr-FR" sz="105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vs</a:t>
                      </a:r>
                      <a:r>
                        <a:rPr lang="fr-FR" sz="105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 PRRSV-D14</a:t>
                      </a:r>
                    </a:p>
                  </a:txBody>
                  <a:tcPr marL="4211" marR="4211" marT="42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5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0.0108</a:t>
                      </a:r>
                    </a:p>
                  </a:txBody>
                  <a:tcPr marL="4211" marR="4211" marT="421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5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*</a:t>
                      </a:r>
                    </a:p>
                  </a:txBody>
                  <a:tcPr marL="4211" marR="4211" marT="4211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147363"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105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Figure 7E:</a:t>
                      </a:r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 Proportions of lymphoid cell populations in the BAL (cluster 10)</a:t>
                      </a:r>
                      <a:endParaRPr lang="en-US" sz="1050" b="1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211" marR="4211" marT="421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105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Mock-D7 </a:t>
                      </a:r>
                      <a:r>
                        <a:rPr lang="fr-FR" sz="105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vs</a:t>
                      </a:r>
                      <a:r>
                        <a:rPr lang="fr-FR" sz="105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 swIAV/PRRSV-D10</a:t>
                      </a:r>
                    </a:p>
                  </a:txBody>
                  <a:tcPr marL="4211" marR="4211" marT="42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5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0.0011</a:t>
                      </a:r>
                    </a:p>
                  </a:txBody>
                  <a:tcPr marL="4211" marR="4211" marT="421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5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**</a:t>
                      </a:r>
                    </a:p>
                  </a:txBody>
                  <a:tcPr marL="4211" marR="4211" marT="4211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147609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105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swIAV/PRRSV-D10 </a:t>
                      </a:r>
                      <a:r>
                        <a:rPr lang="fr-FR" sz="105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vs</a:t>
                      </a:r>
                      <a:r>
                        <a:rPr lang="fr-FR" sz="105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 PRRSV-D14</a:t>
                      </a:r>
                    </a:p>
                  </a:txBody>
                  <a:tcPr marL="4211" marR="4211" marT="42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5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0.0021</a:t>
                      </a:r>
                    </a:p>
                  </a:txBody>
                  <a:tcPr marL="4211" marR="4211" marT="421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5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**</a:t>
                      </a:r>
                    </a:p>
                  </a:txBody>
                  <a:tcPr marL="4211" marR="4211" marT="4211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2903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Figure 8A:</a:t>
                      </a:r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 PRRSV-specific CD4 T cell responses in PBMC (IFN-y+ among CD4+ CD8a-)</a:t>
                      </a:r>
                    </a:p>
                  </a:txBody>
                  <a:tcPr marL="4211" marR="4211" marT="4211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105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Mock-D7 </a:t>
                      </a:r>
                      <a:r>
                        <a:rPr lang="fr-FR" sz="105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vs</a:t>
                      </a:r>
                      <a:r>
                        <a:rPr lang="fr-FR" sz="105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 swIAV/PRRSV-D14</a:t>
                      </a:r>
                    </a:p>
                  </a:txBody>
                  <a:tcPr marL="4211" marR="4211" marT="42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5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0.0089</a:t>
                      </a:r>
                    </a:p>
                  </a:txBody>
                  <a:tcPr marL="4211" marR="4211" marT="42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5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**</a:t>
                      </a:r>
                    </a:p>
                  </a:txBody>
                  <a:tcPr marL="4211" marR="4211" marT="4211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2903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5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Figure S5C:</a:t>
                      </a:r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 Proportions of lymphoid cell populations in the BAL (cluster 3)</a:t>
                      </a:r>
                      <a:endParaRPr lang="en-US" sz="1050" b="1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211" marR="4211" marT="421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105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Mock-D7 </a:t>
                      </a:r>
                      <a:r>
                        <a:rPr lang="fr-FR" sz="105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vs</a:t>
                      </a:r>
                      <a:r>
                        <a:rPr lang="fr-FR" sz="105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 PRRSV-D10</a:t>
                      </a:r>
                    </a:p>
                  </a:txBody>
                  <a:tcPr marL="4211" marR="4211" marT="42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5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0.0207</a:t>
                      </a:r>
                    </a:p>
                  </a:txBody>
                  <a:tcPr marL="4211" marR="4211" marT="42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5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*</a:t>
                      </a:r>
                    </a:p>
                  </a:txBody>
                  <a:tcPr marL="4211" marR="4211" marT="4211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665446943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47</TotalTime>
  <Words>313</Words>
  <Application>Microsoft Office PowerPoint</Application>
  <PresentationFormat>Personnalisé</PresentationFormat>
  <Paragraphs>79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Janaina Grevelinger</dc:creator>
  <cp:lastModifiedBy>Nicolas Bertho</cp:lastModifiedBy>
  <cp:revision>145</cp:revision>
  <dcterms:created xsi:type="dcterms:W3CDTF">2024-09-18T07:24:23Z</dcterms:created>
  <dcterms:modified xsi:type="dcterms:W3CDTF">2025-04-30T13:20:50Z</dcterms:modified>
</cp:coreProperties>
</file>